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media/image2.pct" ContentType="image/x-pict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30B284-FBC8-4087-8F27-63AA60B3D0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381E5-9438-4F0D-92BA-CA1EA89791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6BAE4-8D2C-4A21-B83B-F5B74E5398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8AA526-7375-44FA-A8F5-E77D91D98D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6B7D1-9D97-46DD-8B7D-E591CD6268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BD6DA-2A1A-49BF-A49A-C78C77F2A4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06C36-D48E-40FE-A4E7-9E9A70CE2A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966D4-9F5F-463E-A63F-15AA3F452D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4654B-45BE-472C-A5FD-413CD39E12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AA0C5-F184-43C8-A8FD-5183C4B08D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BF051-A4F8-495A-831D-54F800F980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848E7-7874-4EBC-BFFC-E79BCD813C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FC6AAE-DE8B-4C58-9976-88A380C85AD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ct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28600" y="1219320"/>
          <a:ext cx="3122640" cy="49528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8600" y="1219320"/>
                    <a:ext cx="3122640" cy="4952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154440" y="53352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040" y="44280"/>
            <a:ext cx="21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517120" y="152280"/>
            <a:ext cx="399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GSE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143000" y="838080"/>
            <a:ext cx="79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ll lis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1657440"/>
            <a:ext cx="8991720" cy="487368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154440" y="53352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29680" y="1066680"/>
            <a:ext cx="1186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llN_allPD/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N_mP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040" y="44280"/>
            <a:ext cx="21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517120" y="152280"/>
            <a:ext cx="399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GSE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2" name=""/>
          <p:cNvGraphicFramePr/>
          <p:nvPr/>
        </p:nvGraphicFramePr>
        <p:xfrm>
          <a:off x="152280" y="2209680"/>
          <a:ext cx="8839440" cy="1594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2280" y="2209680"/>
                    <a:ext cx="8839440" cy="1594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"/>
          <p:cNvSpPr/>
          <p:nvPr/>
        </p:nvSpPr>
        <p:spPr>
          <a:xfrm>
            <a:off x="2160" y="108108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07280" y="1600200"/>
            <a:ext cx="1186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llN_allPD/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N_fP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040" y="44280"/>
            <a:ext cx="21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517120" y="152280"/>
            <a:ext cx="399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GSE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9T04:04:12Z</dcterms:created>
  <dc:creator>Kai Sonntag</dc:creator>
  <dc:description/>
  <dc:language>en-US</dc:language>
  <cp:lastModifiedBy>Kai Sonntag</cp:lastModifiedBy>
  <dcterms:modified xsi:type="dcterms:W3CDTF">2009-09-07T21:28:50Z</dcterms:modified>
  <cp:revision>22</cp:revision>
  <dc:subject/>
  <dc:title>PowerPoint Presentation</dc:title>
</cp:coreProperties>
</file>